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wmf" ContentType="image/x-wmf"/>
  <Override PartName="/ppt/embeddings/oleObject1.bin" ContentType="application/vnd.openxmlformats-officedocument.oleObje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2B9807-BE51-4041-882D-9460C5C5340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C7FB6B-73BA-4B05-9AC6-7DDCF36416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793A3D-ED14-45C1-B0F0-39B96C3D07E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314B75-DD67-4772-AE9D-05D9F6BEA60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EA5900-1B11-4FB4-AFE5-416231045FF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CA88D7-DF84-4677-92BF-11249440A1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2F8461-BB27-490D-9D45-0A7D2004C0C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6E8231-EFE2-4E74-B762-89E38414551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BB6E1A-D68A-4139-A9E3-9D01FBEB751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5A960F-6A00-4C17-9D6C-0D3F6A201F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2D81E4-44BE-45B8-BA72-234A5F1A74C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E29C85-C947-49EF-B2D4-259CBF8AB4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03AD06E-8FC5-4BBA-9096-F2E54BC5751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oleObject" Target="../embeddings/oleObject1.bin"/><Relationship Id="rId4" Type="http://schemas.openxmlformats.org/officeDocument/2006/relationships/image" Target="../media/image3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2"/>
          <p:cNvSpPr/>
          <p:nvPr/>
        </p:nvSpPr>
        <p:spPr>
          <a:xfrm>
            <a:off x="4159800" y="3112920"/>
            <a:ext cx="436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R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23"/>
          <p:cNvSpPr/>
          <p:nvPr/>
        </p:nvSpPr>
        <p:spPr>
          <a:xfrm>
            <a:off x="4869360" y="3112920"/>
            <a:ext cx="427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3300"/>
                </a:solidFill>
                <a:latin typeface="Arial"/>
                <a:ea typeface="Arial"/>
              </a:rPr>
              <a:t>R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24"/>
          <p:cNvSpPr/>
          <p:nvPr/>
        </p:nvSpPr>
        <p:spPr>
          <a:xfrm>
            <a:off x="3393720" y="3397320"/>
            <a:ext cx="645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-Ak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25"/>
          <p:cNvSpPr/>
          <p:nvPr/>
        </p:nvSpPr>
        <p:spPr>
          <a:xfrm>
            <a:off x="3571560" y="3695760"/>
            <a:ext cx="467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k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Picture 4" descr=""/>
          <p:cNvPicPr/>
          <p:nvPr/>
        </p:nvPicPr>
        <p:blipFill>
          <a:blip r:embed="rId1"/>
          <a:srcRect l="2311" t="11440" r="2959" b="-10827"/>
          <a:stretch/>
        </p:blipFill>
        <p:spPr>
          <a:xfrm>
            <a:off x="4038480" y="3397320"/>
            <a:ext cx="1371600" cy="30456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5" descr=""/>
          <p:cNvPicPr/>
          <p:nvPr/>
        </p:nvPicPr>
        <p:blipFill>
          <a:blip r:embed="rId2"/>
          <a:srcRect l="0" t="9862" r="0" b="0"/>
          <a:stretch/>
        </p:blipFill>
        <p:spPr>
          <a:xfrm>
            <a:off x="4038480" y="3695760"/>
            <a:ext cx="1371600" cy="304920"/>
          </a:xfrm>
          <a:prstGeom prst="rect">
            <a:avLst/>
          </a:prstGeom>
          <a:ln w="0">
            <a:noFill/>
          </a:ln>
        </p:spPr>
      </p:pic>
      <p:sp>
        <p:nvSpPr>
          <p:cNvPr id="47" name=""/>
          <p:cNvSpPr/>
          <p:nvPr/>
        </p:nvSpPr>
        <p:spPr>
          <a:xfrm>
            <a:off x="304920" y="4898880"/>
            <a:ext cx="8229600" cy="1501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 algn="just">
              <a:spcBef>
                <a:spcPts val="3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l Figure S10. Akt phosphorylation status in CRI-G1 cell lines.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here is no significant difference in levels of Akt (apparent MW, 55 kDa) or P-Akt (apparent MW, 59 kDa) between CRI-G1-RR and RS cells; equal loading of whole cell lysates was confirmed by immunoblotting with anti-tubulin antibody (not shown). Statistical significance was determined by a two-tailed Student’s t-test; scatter plots of all data points are shown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8" name=""/>
          <p:cNvGraphicFramePr/>
          <p:nvPr/>
        </p:nvGraphicFramePr>
        <p:xfrm>
          <a:off x="3249720" y="844560"/>
          <a:ext cx="2367000" cy="277344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9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249720" y="844560"/>
                    <a:ext cx="2367000" cy="2773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1-19T19:03:09Z</dcterms:created>
  <dc:creator>Marta Margeta</dc:creator>
  <dc:description/>
  <dc:language>en-US</dc:language>
  <cp:lastModifiedBy>Marta Margeta</cp:lastModifiedBy>
  <dcterms:modified xsi:type="dcterms:W3CDTF">2010-06-28T21:52:13Z</dcterms:modified>
  <cp:revision>6</cp:revision>
  <dc:subject/>
  <dc:title>Slide 1</dc:title>
</cp:coreProperties>
</file>